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340" r:id="rId2"/>
    <p:sldId id="414" r:id="rId3"/>
    <p:sldId id="410" r:id="rId4"/>
    <p:sldId id="260" r:id="rId5"/>
    <p:sldId id="411" r:id="rId6"/>
    <p:sldId id="412" r:id="rId7"/>
  </p:sldIdLst>
  <p:sldSz cx="6858000" cy="9906000" type="A4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94052DD-AF0D-7DF8-06EE-98C1874BB938}" name="Velda Han" initials="" userId="S::xhan7612@uni.sydney.edu.au::7e310479-5b7f-40c3-bf55-8824597faf44" providerId="AD"/>
  <p188:author id="{D3D9CCFB-6AA2-42FB-1957-A47466647C0C}" name="Hiroya Nishida (SCHN)" initials="" userId="S::Hiroya.Nishida@health.nsw.gov.au::0bf00e1f-7182-408c-922f-cf2d90e624b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–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98"/>
    <p:restoredTop sz="93053"/>
  </p:normalViewPr>
  <p:slideViewPr>
    <p:cSldViewPr snapToGrid="0">
      <p:cViewPr>
        <p:scale>
          <a:sx n="100" d="100"/>
          <a:sy n="100" d="100"/>
        </p:scale>
        <p:origin x="1288" y="-1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0563C12A-8533-3822-9E99-0045E47ADCA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E850CB-E5C8-F677-9D3D-46B2FE49FC5C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BED0743C-93BF-9D46-911F-C0298951D4FE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22B27F4-21CA-9728-7DC2-6A7DDB160553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F0B60FCF-29E6-3153-F808-1301FEA18D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noProof="0"/>
              <a:t>Click to edit Master text styles</a:t>
            </a:r>
          </a:p>
          <a:p>
            <a:pPr lvl="1"/>
            <a:r>
              <a:rPr lang="en-GB" noProof="0"/>
              <a:t>Second level</a:t>
            </a:r>
          </a:p>
          <a:p>
            <a:pPr lvl="2"/>
            <a:r>
              <a:rPr lang="en-GB" noProof="0"/>
              <a:t>Third level</a:t>
            </a:r>
          </a:p>
          <a:p>
            <a:pPr lvl="3"/>
            <a:r>
              <a:rPr lang="en-GB" noProof="0"/>
              <a:t>Fourth level</a:t>
            </a:r>
          </a:p>
          <a:p>
            <a:pPr lvl="4"/>
            <a:r>
              <a:rPr lang="en-GB" noProof="0"/>
              <a:t>Fifth level</a:t>
            </a:r>
            <a:endParaRPr lang="en-US" noProof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B8D2D7-C7BD-9D92-A1EF-7AF95D87D70B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6A3BE4-47F5-4693-D67C-1AF8EE6AC03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D036C0E5-2198-D744-9E3F-89A03A18E0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/>
              <a:t>HIVE cohort 1 single cell RNA sec – QC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D036C0E5-2198-D744-9E3F-89A03A18E063}" type="slidenum">
              <a:rPr lang="en-US" smtClean="0"/>
              <a:pPr>
                <a:defRPr/>
              </a:pPr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7272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/>
              <a:t>Single Cell RNA seq – cohort 2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/>
              <a:t>Features that have less than 300 genes and 600 unique transcript molecules were filtered</a:t>
            </a:r>
          </a:p>
          <a:p>
            <a:endParaRPr lang="en-AU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D036C0E5-2198-D744-9E3F-89A03A18E063}" type="slidenum">
              <a:rPr lang="en-US" smtClean="0"/>
              <a:pPr>
                <a:defRPr/>
              </a:pPr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0193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/>
              <a:t>Proteomics RNA seq – cohort 2</a:t>
            </a:r>
            <a:r>
              <a:rPr lang="en-AU" altLang="ja-JP" sz="1200" dirty="0"/>
              <a:t>, QC</a:t>
            </a:r>
            <a:endParaRPr lang="en-US" altLang="ja-JP" sz="120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D036C0E5-2198-D744-9E3F-89A03A18E063}" type="slidenum">
              <a:rPr lang="en-US" smtClean="0"/>
              <a:pPr>
                <a:defRPr/>
              </a:pPr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2670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 err="1"/>
              <a:t>Phosphoproteomics</a:t>
            </a:r>
            <a:r>
              <a:rPr lang="en-US" altLang="ja-JP" sz="1200" dirty="0"/>
              <a:t> RNA seq – cohort 2</a:t>
            </a:r>
            <a:r>
              <a:rPr lang="en-AU" altLang="ja-JP" sz="1200" dirty="0"/>
              <a:t>, QC</a:t>
            </a:r>
            <a:endParaRPr lang="en-US" altLang="ja-JP" sz="120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D036C0E5-2198-D744-9E3F-89A03A18E063}" type="slidenum">
              <a:rPr lang="en-US" smtClean="0"/>
              <a:pPr>
                <a:defRPr/>
              </a:pPr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3943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E8553D-4001-2893-CBB3-DA225736E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DD1945-A3D0-5C4C-A11A-4CBB30585BFD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9E3E81-0EF1-4351-703C-827300EAD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B63D4D-0020-D15B-30DA-81A2F7700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37EE0-8AE4-7047-81D7-EBF3A5CD43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511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17EADC-3ED9-2020-13E5-7F7497812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F57169-2D8E-9B4D-92CF-746C3DC03880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C0DDB3-8D99-F780-2B85-A68169E20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72BA34-F197-D353-DC40-B0A17BD8F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75D8C7-BF9B-F142-98ED-109ADC510F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0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727F4-B24A-CD7F-5EA9-2E207BBF8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A21493-0C75-9A42-B448-234E27570F20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92A076-1AAC-975F-1006-05CCE07FB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AE3F98-45E9-4F37-3A7C-107C49275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86A84B-CE4D-D545-9474-776096ED4B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620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9FFA21-0C6E-180B-EEBE-480C038E8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2CB977-9CF9-9242-923F-BC53796E4FEF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331F2A-C52E-9792-F368-FD9A2A3C7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0D3AA2-7B31-3445-FBB7-5ED690BCA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392C75-12FA-C54B-82A5-7600EDEA461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0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AAD524-FFEB-FF31-DEFB-75AF6FDCC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AC0CDE-6884-0E40-A975-5E80D44A0A4B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A92B4B-3DDD-8700-D4AC-52031B8D6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67B036-7B63-BF8B-94E9-93421411E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45E526-6642-3F4E-917E-9D0D2C2D74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125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B6CD1BA-3B10-61D2-997D-DE761D59A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7B24DA-AD79-EA4D-91DE-06C0698A047B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F620460-9E67-0106-DF26-81BBD624E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24CE7C45-175B-E6BA-1226-D24A38902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A61C2C-693D-764F-BAFD-5E79C13FD5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832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B7BEDB7-7E0F-6575-0D58-8A22128AB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1AB187-EA2A-3C45-B0CE-76C3DEB5277C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F487DDBB-61A0-EA83-15AA-6099B90C6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D1805FD8-7332-DF44-E6C8-92F7FFA3F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6F5BDA-0CC6-B147-8B2B-88CBA16CFC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333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11B3060F-FA2C-66C1-8BC8-7CFC0257E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328356-38A2-CA44-86D8-60C0E3A47D84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8FD02A13-B481-9E51-B21F-211F11B0A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2BA955E-D419-A6CF-B3E1-61DB8F138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F3E93D-CBEF-D343-A9ED-A5595F4200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491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2B425659-8992-7AB0-A067-6676C9758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D9129-EF70-264C-8BBC-E06542DA780A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D17348B-FA0C-D094-E19D-CF83A842A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5258ED01-A8FE-7EA5-CEB3-A47856E74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4022A6-45F1-804E-B15C-E61843FA7B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164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7BFE279-48B5-BC39-7BB3-1DBDE4D87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146F9F-3724-C547-B1DE-4048EA3D6D52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0E5260C5-7A75-D121-DF30-3AAB838D9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6B407F9-74CD-B213-9B0F-53A6E67AA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669882-D7FB-9B47-A645-0D4C42C9C2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06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2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GB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BCC94525-13D6-E12D-F08F-3A08FB607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76F4C-F94C-424B-AFB6-0991E280BC60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CF6D14C7-83E1-866A-9161-96D549974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F14BF38-E338-DA20-DA9F-19F61BA10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6C7C31-FF70-9845-BC02-1030192F8E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80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26F03581-848F-2232-4126-DEF77C47DEBF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/>
              <a:t>Click to edit Master title style</a:t>
            </a:r>
            <a:endParaRPr lang="en-US" altLang="en-US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31756E3A-825D-AEE1-2C37-ECB6F5C0EB7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JP"/>
              <a:t>Click to edit Master text styles</a:t>
            </a:r>
          </a:p>
          <a:p>
            <a:pPr lvl="1"/>
            <a:r>
              <a:rPr lang="en-GB" altLang="en-JP"/>
              <a:t>Second level</a:t>
            </a:r>
          </a:p>
          <a:p>
            <a:pPr lvl="2"/>
            <a:r>
              <a:rPr lang="en-GB" altLang="en-JP"/>
              <a:t>Third level</a:t>
            </a:r>
          </a:p>
          <a:p>
            <a:pPr lvl="3"/>
            <a:r>
              <a:rPr lang="en-GB" altLang="en-JP"/>
              <a:t>Fourth level</a:t>
            </a:r>
          </a:p>
          <a:p>
            <a:pPr lvl="4"/>
            <a:r>
              <a:rPr lang="en-GB" altLang="en-JP"/>
              <a:t>Fifth level</a:t>
            </a:r>
            <a:endParaRPr lang="en-US" alt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6A527F-7FA2-296A-689B-69F8C35785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DF25A7D-EF33-6941-8644-2C3B5D63DE32}" type="datetimeFigureOut">
              <a:rPr lang="en-US"/>
              <a:pPr>
                <a:defRPr/>
              </a:pPr>
              <a:t>1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389CA3-C1E2-3BE1-D466-CB3F0C3521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370938-740B-E98C-3C96-92E9C8B2AC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84B7949-027D-7448-AF76-95446645E39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anose="020B000402020202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タイトル 1">
            <a:extLst>
              <a:ext uri="{FF2B5EF4-FFF2-40B4-BE49-F238E27FC236}">
                <a16:creationId xmlns:a16="http://schemas.microsoft.com/office/drawing/2014/main" id="{2DB0D213-7BE2-5872-E369-2241124EBDA1}"/>
              </a:ext>
            </a:extLst>
          </p:cNvPr>
          <p:cNvSpPr>
            <a:spLocks noGrp="1" noChangeArrowheads="1"/>
          </p:cNvSpPr>
          <p:nvPr>
            <p:ph type="ctrTitle"/>
          </p:nvPr>
        </p:nvSpPr>
        <p:spPr>
          <a:xfrm>
            <a:off x="514350" y="606005"/>
            <a:ext cx="5829300" cy="3449637"/>
          </a:xfrm>
        </p:spPr>
        <p:txBody>
          <a:bodyPr/>
          <a:lstStyle/>
          <a:p>
            <a:pPr eaLnBrk="1" hangingPunct="1"/>
            <a:r>
              <a:rPr lang="en-AU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br>
              <a:rPr lang="en-AU" altLang="en-US" sz="2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AU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28A54BD-8AB5-3579-AB9E-5B0F72A163B9}"/>
              </a:ext>
            </a:extLst>
          </p:cNvPr>
          <p:cNvSpPr txBox="1"/>
          <p:nvPr/>
        </p:nvSpPr>
        <p:spPr>
          <a:xfrm>
            <a:off x="161365" y="233593"/>
            <a:ext cx="31018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Figure S1: Exploratory bulk RNA seq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2923D7-E590-8526-380E-711146D0145A}"/>
              </a:ext>
            </a:extLst>
          </p:cNvPr>
          <p:cNvSpPr txBox="1"/>
          <p:nvPr/>
        </p:nvSpPr>
        <p:spPr>
          <a:xfrm>
            <a:off x="464561" y="7710176"/>
            <a:ext cx="592887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the bulk RNA sequencing, k=10 (factors of unwanted variation) were used to remove genes that had minimal differential expression, compared to negative control genes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x and whiskers relative log expression plot of samples after normalization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nectivity enrichment network plot (CNET) of top 2 most downregulated pathways: Structural constituent of ribosome and ribosome subunit </a:t>
            </a:r>
            <a:endParaRPr lang="en-SG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2F9BAC6-948B-4150-EE36-A52A1EF16C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9000" y="757406"/>
            <a:ext cx="3600000" cy="180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3FFEBAC-F7B8-73C3-7B8D-0E8E76A01AD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347" b="27437"/>
          <a:stretch/>
        </p:blipFill>
        <p:spPr>
          <a:xfrm>
            <a:off x="1463240" y="2888855"/>
            <a:ext cx="3600000" cy="126388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B73EF3A-8D87-28EF-DB55-271B8F032FFD}"/>
              </a:ext>
            </a:extLst>
          </p:cNvPr>
          <p:cNvSpPr txBox="1"/>
          <p:nvPr/>
        </p:nvSpPr>
        <p:spPr>
          <a:xfrm>
            <a:off x="1219556" y="703808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A1A5760-F1BE-3B73-2B0E-CB4C778C963C}"/>
              </a:ext>
            </a:extLst>
          </p:cNvPr>
          <p:cNvSpPr txBox="1"/>
          <p:nvPr/>
        </p:nvSpPr>
        <p:spPr>
          <a:xfrm>
            <a:off x="1225652" y="2611856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A783149-F4E1-7096-4771-B1AC135ECC14}"/>
              </a:ext>
            </a:extLst>
          </p:cNvPr>
          <p:cNvSpPr txBox="1"/>
          <p:nvPr/>
        </p:nvSpPr>
        <p:spPr>
          <a:xfrm>
            <a:off x="1213460" y="4666208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DB40A47-3F7F-38A7-5D47-001D5B6F4C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2302" y="4381772"/>
            <a:ext cx="3600000" cy="3099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1921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picture containing plot, screenshot, diagram, line&#10;&#10;Description automatically generated">
            <a:extLst>
              <a:ext uri="{FF2B5EF4-FFF2-40B4-BE49-F238E27FC236}">
                <a16:creationId xmlns:a16="http://schemas.microsoft.com/office/drawing/2014/main" id="{BB6DF37D-396B-BDAA-C0D0-2EAA8D47076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28864"/>
          <a:stretch/>
        </p:blipFill>
        <p:spPr>
          <a:xfrm>
            <a:off x="416859" y="842863"/>
            <a:ext cx="6024282" cy="1186237"/>
          </a:xfrm>
          <a:prstGeom prst="rect">
            <a:avLst/>
          </a:prstGeom>
        </p:spPr>
      </p:pic>
      <p:pic>
        <p:nvPicPr>
          <p:cNvPr id="6" name="Picture 3" descr="A close-up of a chart&#10;&#10;Description automatically generated with low confidence">
            <a:extLst>
              <a:ext uri="{FF2B5EF4-FFF2-40B4-BE49-F238E27FC236}">
                <a16:creationId xmlns:a16="http://schemas.microsoft.com/office/drawing/2014/main" id="{4EF7D1A6-34A1-3C9F-CFB0-9C7B0F3A43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9000" y="2576351"/>
            <a:ext cx="5400000" cy="282208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2BC467-E4BD-8C20-2178-6564B04A7C9D}"/>
              </a:ext>
            </a:extLst>
          </p:cNvPr>
          <p:cNvSpPr txBox="1"/>
          <p:nvPr/>
        </p:nvSpPr>
        <p:spPr>
          <a:xfrm>
            <a:off x="161365" y="233593"/>
            <a:ext cx="4217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Figure S2: Single cell RNA seq analysis – Cohort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5FA41E3-9138-6D74-D752-77DB64775C2E}"/>
              </a:ext>
            </a:extLst>
          </p:cNvPr>
          <p:cNvSpPr txBox="1"/>
          <p:nvPr/>
        </p:nvSpPr>
        <p:spPr>
          <a:xfrm>
            <a:off x="286868" y="648944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1F1D0E-3E01-5D05-150D-E215561678CC}"/>
              </a:ext>
            </a:extLst>
          </p:cNvPr>
          <p:cNvSpPr txBox="1"/>
          <p:nvPr/>
        </p:nvSpPr>
        <p:spPr>
          <a:xfrm>
            <a:off x="295833" y="2576351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03C045-F833-85C0-5EA0-308A69276591}"/>
              </a:ext>
            </a:extLst>
          </p:cNvPr>
          <p:cNvSpPr txBox="1"/>
          <p:nvPr/>
        </p:nvSpPr>
        <p:spPr>
          <a:xfrm>
            <a:off x="464561" y="6187066"/>
            <a:ext cx="592887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features, counts and percentage of mitochondrial genes per sample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t map of top differentially expressed genes based on cell type: genes are the top 5 markers of differential analysis between cell types (FDR &lt;0.05) ranked by the difference in proportion of cells expressing the respective gene</a:t>
            </a:r>
          </a:p>
        </p:txBody>
      </p:sp>
    </p:spTree>
    <p:extLst>
      <p:ext uri="{BB962C8B-B14F-4D97-AF65-F5344CB8AC3E}">
        <p14:creationId xmlns:p14="http://schemas.microsoft.com/office/powerpoint/2010/main" val="11225179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">
            <a:extLst>
              <a:ext uri="{FF2B5EF4-FFF2-40B4-BE49-F238E27FC236}">
                <a16:creationId xmlns:a16="http://schemas.microsoft.com/office/drawing/2014/main" id="{219CA93E-8D1C-251C-D29F-C8FAB90647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26542" y="2432124"/>
            <a:ext cx="3789276" cy="187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590D003E-AB99-1FF5-8A56-B6F4E12126B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0319" y="703277"/>
            <a:ext cx="4401722" cy="1492399"/>
          </a:xfrm>
          <a:prstGeom prst="rect">
            <a:avLst/>
          </a:prstGeom>
        </p:spPr>
      </p:pic>
      <p:pic>
        <p:nvPicPr>
          <p:cNvPr id="21" name="Picture 6">
            <a:extLst>
              <a:ext uri="{FF2B5EF4-FFF2-40B4-BE49-F238E27FC236}">
                <a16:creationId xmlns:a16="http://schemas.microsoft.com/office/drawing/2014/main" id="{AB134E72-E191-107A-AD84-6A18FD4473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23047" y="4306424"/>
            <a:ext cx="5611906" cy="28059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9CFA24-055C-2489-E90F-39D36B636E3C}"/>
              </a:ext>
            </a:extLst>
          </p:cNvPr>
          <p:cNvSpPr txBox="1"/>
          <p:nvPr/>
        </p:nvSpPr>
        <p:spPr>
          <a:xfrm>
            <a:off x="179294" y="173400"/>
            <a:ext cx="4217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Figure S3: Single cell RNA seq analysis – Cohort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CBF3B44-302A-74FB-640E-8B7236E9D471}"/>
              </a:ext>
            </a:extLst>
          </p:cNvPr>
          <p:cNvSpPr txBox="1"/>
          <p:nvPr/>
        </p:nvSpPr>
        <p:spPr>
          <a:xfrm>
            <a:off x="712870" y="648944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52B0427-F9DC-4218-3994-D8ADC10C24FA}"/>
              </a:ext>
            </a:extLst>
          </p:cNvPr>
          <p:cNvSpPr txBox="1"/>
          <p:nvPr/>
        </p:nvSpPr>
        <p:spPr>
          <a:xfrm>
            <a:off x="703547" y="2576351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0E117E1-AB2E-240C-EFE4-FAFA04EB3F50}"/>
              </a:ext>
            </a:extLst>
          </p:cNvPr>
          <p:cNvSpPr txBox="1"/>
          <p:nvPr/>
        </p:nvSpPr>
        <p:spPr>
          <a:xfrm>
            <a:off x="712154" y="4432045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921657-35AB-496F-FE54-0963AD2BFE3F}"/>
              </a:ext>
            </a:extLst>
          </p:cNvPr>
          <p:cNvSpPr txBox="1"/>
          <p:nvPr/>
        </p:nvSpPr>
        <p:spPr>
          <a:xfrm>
            <a:off x="464561" y="7546895"/>
            <a:ext cx="592887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features, counts and percentage of mitochondrial genes per sample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form manifold approximation and projection (UMAP) of single cells from single cell RNA sequencing.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t map of top differentially expressed genes based on cell type: genes are the top 5 markers of differential analysis between cell types (FDR &lt;0.05) ranked by the difference in proportion of cells expressing the respective gene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38BC48E6-3743-1540-C7E5-7983236E0B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975" y="2985212"/>
            <a:ext cx="2160000" cy="1543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2AF52DB4-4593-B427-94B7-1BD7839AC9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8508" y="3033799"/>
            <a:ext cx="2160000" cy="1661538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487B8F36-AA32-0E92-04B1-C936189C3C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5063" y="475205"/>
            <a:ext cx="2160000" cy="2160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3719D02-5627-5DA9-EA12-4231E79B9A3A}"/>
              </a:ext>
            </a:extLst>
          </p:cNvPr>
          <p:cNvSpPr txBox="1"/>
          <p:nvPr/>
        </p:nvSpPr>
        <p:spPr>
          <a:xfrm>
            <a:off x="175178" y="179614"/>
            <a:ext cx="35381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Figure S4: Proteomics analysis – Cohort 2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E9A54834-01B5-B0CE-0802-F74EEBD7BC4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2606" t="23117" b="31401"/>
          <a:stretch/>
        </p:blipFill>
        <p:spPr>
          <a:xfrm>
            <a:off x="1844975" y="5210663"/>
            <a:ext cx="2880000" cy="14539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F835A8B-50DE-F176-66E9-8F26C8D76EE4}"/>
              </a:ext>
            </a:extLst>
          </p:cNvPr>
          <p:cNvSpPr txBox="1"/>
          <p:nvPr/>
        </p:nvSpPr>
        <p:spPr>
          <a:xfrm>
            <a:off x="744069" y="550331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6FF2B6-75A1-0FE1-8CF0-5B093B5C943A}"/>
              </a:ext>
            </a:extLst>
          </p:cNvPr>
          <p:cNvSpPr txBox="1"/>
          <p:nvPr/>
        </p:nvSpPr>
        <p:spPr>
          <a:xfrm>
            <a:off x="770964" y="2836326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B1E0A1A-260B-84D7-B205-1BE0FB7CFA14}"/>
              </a:ext>
            </a:extLst>
          </p:cNvPr>
          <p:cNvSpPr txBox="1"/>
          <p:nvPr/>
        </p:nvSpPr>
        <p:spPr>
          <a:xfrm>
            <a:off x="3263151" y="541368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836356-288B-6849-BEB7-A182BD915527}"/>
              </a:ext>
            </a:extLst>
          </p:cNvPr>
          <p:cNvSpPr txBox="1"/>
          <p:nvPr/>
        </p:nvSpPr>
        <p:spPr>
          <a:xfrm>
            <a:off x="3307975" y="2827361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A52AF2C-B358-F0F6-47C9-232427C81749}"/>
              </a:ext>
            </a:extLst>
          </p:cNvPr>
          <p:cNvSpPr txBox="1"/>
          <p:nvPr/>
        </p:nvSpPr>
        <p:spPr>
          <a:xfrm>
            <a:off x="1649502" y="5113358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DC0CE9-C719-6D59-5827-A8AC29B16083}"/>
              </a:ext>
            </a:extLst>
          </p:cNvPr>
          <p:cNvSpPr txBox="1"/>
          <p:nvPr/>
        </p:nvSpPr>
        <p:spPr>
          <a:xfrm>
            <a:off x="744069" y="7166654"/>
            <a:ext cx="592887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ncipal component analysis of proteomics shows good discrimination between children with neurodevelopmental regression versus controls </a:t>
            </a:r>
            <a:endParaRPr lang="en-SG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x and whiskers relative log expression plot of samples after normalization</a:t>
            </a:r>
          </a:p>
          <a:p>
            <a:pPr marL="228600" indent="-228600">
              <a:buFontTx/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iolin plot of protein counts of samples after normalization </a:t>
            </a:r>
            <a:endParaRPr lang="en-US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olcano plot of differentially expressed proteins between children with neurodevelopmental regression compared to controls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nectivity enrichment plot (CNET) of GSEA GO upregulated pathway-NuA4 histone acetyltransferase complex, H4/H2A histone acetyltransferase complex</a:t>
            </a:r>
            <a:endParaRPr lang="en-SG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373C2C5D-9D1E-2B14-F2DF-EB2715C190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99563" y="818367"/>
            <a:ext cx="2160000" cy="15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90191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507D999-B423-6FF4-EA67-295D42B32D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8082" y="2805610"/>
            <a:ext cx="2160000" cy="166153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05F228D-1EB3-4F9A-8BC9-B32F672A27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5517" y="647905"/>
            <a:ext cx="2160000" cy="216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B30067CF-F547-5DC4-8337-61386D24A3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8822" y="4791637"/>
            <a:ext cx="3600000" cy="27450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1A6BC7E-6178-A199-679A-90E744033EC0}"/>
              </a:ext>
            </a:extLst>
          </p:cNvPr>
          <p:cNvSpPr txBox="1"/>
          <p:nvPr/>
        </p:nvSpPr>
        <p:spPr>
          <a:xfrm>
            <a:off x="94605" y="190097"/>
            <a:ext cx="4273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Figure S5: Phosphoproteomics analysis – Cohort 2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0AB34C-1790-B353-A848-06E178DE6942}"/>
              </a:ext>
            </a:extLst>
          </p:cNvPr>
          <p:cNvSpPr txBox="1"/>
          <p:nvPr/>
        </p:nvSpPr>
        <p:spPr>
          <a:xfrm>
            <a:off x="744069" y="639976"/>
            <a:ext cx="2554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B8A7312-2AAD-3086-E750-C88FCC032B01}"/>
              </a:ext>
            </a:extLst>
          </p:cNvPr>
          <p:cNvSpPr txBox="1"/>
          <p:nvPr/>
        </p:nvSpPr>
        <p:spPr>
          <a:xfrm>
            <a:off x="3514159" y="666872"/>
            <a:ext cx="1559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F262F6-576F-E33F-4923-3B5F0FF2C9B5}"/>
              </a:ext>
            </a:extLst>
          </p:cNvPr>
          <p:cNvSpPr txBox="1"/>
          <p:nvPr/>
        </p:nvSpPr>
        <p:spPr>
          <a:xfrm>
            <a:off x="1568822" y="2809435"/>
            <a:ext cx="1559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27D7507-3705-BC28-6503-3E292AEC593B}"/>
              </a:ext>
            </a:extLst>
          </p:cNvPr>
          <p:cNvSpPr txBox="1"/>
          <p:nvPr/>
        </p:nvSpPr>
        <p:spPr>
          <a:xfrm>
            <a:off x="1577787" y="4916141"/>
            <a:ext cx="15598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7F6BDB-F0E0-FFFF-7377-8DE95671617C}"/>
              </a:ext>
            </a:extLst>
          </p:cNvPr>
          <p:cNvSpPr txBox="1"/>
          <p:nvPr/>
        </p:nvSpPr>
        <p:spPr>
          <a:xfrm>
            <a:off x="744069" y="7861125"/>
            <a:ext cx="565673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ncipal component analysis of phosphoproteomics shows good discrimination between children with neurodevelopmental regression versus controls </a:t>
            </a:r>
            <a:endParaRPr lang="en-SG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x and whiskers relative log expression plot of samples after normalization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olcano plot of differentially expressed phosphopeptides between children with neurodevelopmental regression compared to controls </a:t>
            </a:r>
          </a:p>
          <a:p>
            <a:pPr marL="228600" indent="-228600">
              <a:buAutoNum type="alphaUcParenBoth"/>
            </a:pPr>
            <a:r>
              <a:rPr 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nectivity enrichment plot (CNET) of second most downregulated ORA GO pathway- chromatin binding</a:t>
            </a:r>
            <a:endParaRPr lang="en-SG" sz="1000" kern="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2721D20D-5518-75E5-CB5C-6D987853FA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8051" y="871738"/>
            <a:ext cx="2189363" cy="1532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0652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24</TotalTime>
  <Words>426</Words>
  <Application>Microsoft Macintosh PowerPoint</Application>
  <PresentationFormat>A4 Paper (210x297 mm)</PresentationFormat>
  <Paragraphs>49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VE PANS scRNAseq data</dc:title>
  <dc:subject/>
  <dc:creator>Velda Han</dc:creator>
  <cp:keywords/>
  <dc:description/>
  <cp:lastModifiedBy>Velda Han</cp:lastModifiedBy>
  <cp:revision>247</cp:revision>
  <dcterms:created xsi:type="dcterms:W3CDTF">2024-02-15T08:19:38Z</dcterms:created>
  <dcterms:modified xsi:type="dcterms:W3CDTF">2025-01-27T15:48:04Z</dcterms:modified>
  <cp:category/>
</cp:coreProperties>
</file>